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4" r:id="rId2"/>
    <p:sldId id="310" r:id="rId3"/>
    <p:sldId id="258" r:id="rId4"/>
    <p:sldId id="30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096"/>
  </p:normalViewPr>
  <p:slideViewPr>
    <p:cSldViewPr snapToGrid="0" snapToObjects="1">
      <p:cViewPr>
        <p:scale>
          <a:sx n="115" d="100"/>
          <a:sy n="115" d="100"/>
        </p:scale>
        <p:origin x="152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D6AEC9-9BFD-F044-99FF-858EE2A9FC75}" type="datetimeFigureOut">
              <a:rPr lang="en-US" smtClean="0"/>
              <a:t>4/30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64A671-521E-4F42-A3EC-E69785CEA0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8293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8AAF74-EB03-3643-B272-8737CD44DC4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17468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3F9518-03FC-EF44-803B-1F10B2EA6D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3B58ED-F4FC-A14D-80A0-6F0C71747CB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15703E-72C4-5044-A76A-6FAC06199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848F01-5343-944A-AF73-FC267635C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FD6184-BB92-7E47-A7BA-E845D85F68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133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BBD491-A547-0B44-9351-41733A4E22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2C086A-9528-F549-B53B-2588AEB7E7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0549ED-CB2E-9E4A-BDF5-EE5E6A401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3ACEAD-FD92-434B-8BA8-DDF1B5924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DC43AB-2D22-2F43-9FDF-70CCC3304D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809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4EA91B-0290-8347-A2AB-0A6C3D7232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D923E3-9C29-A344-8FCF-E7DB36A009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17E625-590A-2541-A911-4C9DF52EF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9B157C-9A36-0F44-9BC3-F8841F95A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C7C028-65FB-B642-8B06-E325C25EB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037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F70CA7-AC7B-6041-AEAC-883D6B6AD5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92E6ED-8E0F-AC4C-8A5C-EAA3630093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748F37-1091-2C40-8B3F-0BB68556E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3D60D8-9A81-6C45-9D9B-C2E6AD54FC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B40B20-7FBB-3A4A-A9B8-D3264C6FE7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3791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2D8DC1-FDA6-3B44-B3A5-DA72CCD5F9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7FEF6B-D5B1-0A41-8BE3-02B2EE480D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8A36E0-07B3-2F40-8252-196E7F52A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D2A17B-CAC7-6649-AF95-C2371F93C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D796A7-9704-DF40-A80B-57FAF1D46D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953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6D4C5E-A063-6349-B537-A48BC78FCA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E24A68-D12E-3E4D-BF32-65E9E0606D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4AA7FEE-BECF-704E-8F11-FAB9BC407E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FAC975-153C-2940-ABFE-AFFC5AC73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BEBA03-61B6-D843-9324-1B25BED62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1B1D13-D3E0-5947-A3BC-BE94DD276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155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97293-C709-8C42-BCDE-3951B16785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C50F1F-3B8F-3646-814F-0BBA280A99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39037B-CCDC-A247-8DBF-236C111322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3DFDA7-60E6-2045-9EF3-A561057FB1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87868CC-A609-E94D-B3BD-3328ED79E2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B37C19-4E81-0F45-AED8-7C1387764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9B629C0-4939-5E46-A80C-875755E8D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6E2FCD4-7E56-FC48-B14E-5207EF9ED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222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067464-520F-FD4D-B1BE-76910D975C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136D567-F561-134D-9E28-5610B341E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ADB3DF-4288-A246-A15E-55D3423FE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1B859A-0CCE-A04A-848E-FFC58BAAD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403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9419C5-7B7C-8546-8962-796AA69E87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3E9F30-7FF6-854B-B94E-5E89C5FAD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D7632A-D6CA-FA44-AA8F-4A668D14B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471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21080-B3F0-6B40-8336-AEA7945688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2C488B-B7DE-6A4E-A3E6-1226B9A8CA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8490B3-BA14-2E4D-B65E-66506722D6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B0DC60-93F1-3C4A-91EB-497BBF9C3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0526F2-1DF3-B140-8A88-BFEB06792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48B414-9600-334A-B367-DDF0A71D8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588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20646-31EA-484A-8024-77F411F59A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67B4EDB-9EB9-CF49-BEA5-C89D696694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EC794B-D428-2347-82E7-8C555C0316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F551B5-BDF2-7548-841F-588DFBD5E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805197-B63F-A747-8A12-FD785172E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894125-D82B-9B43-8AE9-0961DB807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860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01CBED9-23AB-0C4B-B1EB-7200915250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CCFE29-2E2F-554A-9D87-70BE6E8DC1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A789E9-008E-3F44-AD79-D0E45001F9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38764-F598-E147-848D-6989BABA43D8}" type="datetimeFigureOut">
              <a:rPr lang="en-US" smtClean="0"/>
              <a:t>4/30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061229-D80F-764C-87B2-7F36659D54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7B2869-23BD-7A4F-8D60-53AF933FAD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985C25-577C-B64E-BDDA-0BC3BA6825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251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Picture 96">
            <a:extLst>
              <a:ext uri="{FF2B5EF4-FFF2-40B4-BE49-F238E27FC236}">
                <a16:creationId xmlns:a16="http://schemas.microsoft.com/office/drawing/2014/main" id="{84AE8310-13E9-A548-B922-92F8F678C7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21607" y="3581400"/>
            <a:ext cx="3308090" cy="3308090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A4948F74-E111-B54B-BFE1-CC7513BA75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395" y="4797683"/>
            <a:ext cx="5088835" cy="2370440"/>
          </a:xfrm>
          <a:prstGeom prst="rect">
            <a:avLst/>
          </a:prstGeom>
        </p:spPr>
      </p:pic>
      <p:pic>
        <p:nvPicPr>
          <p:cNvPr id="99" name="Picture 98">
            <a:extLst>
              <a:ext uri="{FF2B5EF4-FFF2-40B4-BE49-F238E27FC236}">
                <a16:creationId xmlns:a16="http://schemas.microsoft.com/office/drawing/2014/main" id="{5BFDB76E-3029-7D4D-9E6E-7471EFE4CE89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8406880" y="0"/>
            <a:ext cx="3467620" cy="3702358"/>
          </a:xfrm>
          <a:prstGeom prst="rect">
            <a:avLst/>
          </a:prstGeom>
        </p:spPr>
      </p:pic>
      <p:pic>
        <p:nvPicPr>
          <p:cNvPr id="101" name="Picture 100">
            <a:extLst>
              <a:ext uri="{FF2B5EF4-FFF2-40B4-BE49-F238E27FC236}">
                <a16:creationId xmlns:a16="http://schemas.microsoft.com/office/drawing/2014/main" id="{5EEACAB6-5AE5-304E-A419-B648065E4B13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4477728" y="0"/>
            <a:ext cx="3332772" cy="3702358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DDF2EB50-7A7B-454F-A550-9C08CE54A67C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8811776" y="3939821"/>
          <a:ext cx="3062724" cy="26080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31362">
                  <a:extLst>
                    <a:ext uri="{9D8B030D-6E8A-4147-A177-3AD203B41FA5}">
                      <a16:colId xmlns:a16="http://schemas.microsoft.com/office/drawing/2014/main" val="58107269"/>
                    </a:ext>
                  </a:extLst>
                </a:gridCol>
                <a:gridCol w="1531362">
                  <a:extLst>
                    <a:ext uri="{9D8B030D-6E8A-4147-A177-3AD203B41FA5}">
                      <a16:colId xmlns:a16="http://schemas.microsoft.com/office/drawing/2014/main" val="1697907124"/>
                    </a:ext>
                  </a:extLst>
                </a:gridCol>
              </a:tblGrid>
              <a:tr h="403514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Stag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No. of total 300bp til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9663596"/>
                  </a:ext>
                </a:extLst>
              </a:tr>
              <a:tr h="268853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Sper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459,09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9035132"/>
                  </a:ext>
                </a:extLst>
              </a:tr>
              <a:tr h="268853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G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33,04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7585703"/>
                  </a:ext>
                </a:extLst>
              </a:tr>
              <a:tr h="268853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In vivo MI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24,63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0048503"/>
                  </a:ext>
                </a:extLst>
              </a:tr>
              <a:tr h="268853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In vitro MI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39,07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9561001"/>
                  </a:ext>
                </a:extLst>
              </a:tr>
              <a:tr h="268853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2-Cel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69,9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065230"/>
                  </a:ext>
                </a:extLst>
              </a:tr>
              <a:tr h="268853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4-Cel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54,27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5371730"/>
                  </a:ext>
                </a:extLst>
              </a:tr>
              <a:tr h="268853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8-Cel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69,98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5247527"/>
                  </a:ext>
                </a:extLst>
              </a:tr>
              <a:tr h="268853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16-Cel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179,32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4556267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689E1EF4-BF5B-F842-BA62-665E2522DF71}"/>
              </a:ext>
            </a:extLst>
          </p:cNvPr>
          <p:cNvSpPr txBox="1"/>
          <p:nvPr/>
        </p:nvSpPr>
        <p:spPr>
          <a:xfrm>
            <a:off x="26504" y="6494160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S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5D66973-6032-1D4A-92ED-A0D0881ED851}"/>
              </a:ext>
            </a:extLst>
          </p:cNvPr>
          <p:cNvSpPr txBox="1"/>
          <p:nvPr/>
        </p:nvSpPr>
        <p:spPr>
          <a:xfrm>
            <a:off x="75234" y="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A802F20-C8AC-3441-8A3B-039CE10C9432}"/>
              </a:ext>
            </a:extLst>
          </p:cNvPr>
          <p:cNvSpPr txBox="1"/>
          <p:nvPr/>
        </p:nvSpPr>
        <p:spPr>
          <a:xfrm>
            <a:off x="4154834" y="547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A13F75-B0FF-5940-98BD-62E436C90110}"/>
              </a:ext>
            </a:extLst>
          </p:cNvPr>
          <p:cNvSpPr txBox="1"/>
          <p:nvPr/>
        </p:nvSpPr>
        <p:spPr>
          <a:xfrm>
            <a:off x="8252030" y="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094A39-A5EE-B44B-9771-C79B0AC9C496}"/>
              </a:ext>
            </a:extLst>
          </p:cNvPr>
          <p:cNvSpPr txBox="1"/>
          <p:nvPr/>
        </p:nvSpPr>
        <p:spPr>
          <a:xfrm>
            <a:off x="64395" y="4652513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97E076B-B4D4-DC47-8D08-89EE27FC59D9}"/>
              </a:ext>
            </a:extLst>
          </p:cNvPr>
          <p:cNvSpPr txBox="1"/>
          <p:nvPr/>
        </p:nvSpPr>
        <p:spPr>
          <a:xfrm>
            <a:off x="4694273" y="3830881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78E309C-C167-DE41-8CE8-0E0E5E5F0D94}"/>
              </a:ext>
            </a:extLst>
          </p:cNvPr>
          <p:cNvSpPr txBox="1"/>
          <p:nvPr/>
        </p:nvSpPr>
        <p:spPr>
          <a:xfrm>
            <a:off x="8352127" y="3830881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07BF506-3ADC-824E-AB68-90A6EC82AC1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2450" y="87976"/>
            <a:ext cx="4036539" cy="4259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48841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F439F5A1-A7D4-3B4E-8CC5-B37E069D5A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04" y="398079"/>
            <a:ext cx="6034003" cy="295421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8AA95E8F-1E23-C741-AC97-945DBEBF3920}"/>
              </a:ext>
            </a:extLst>
          </p:cNvPr>
          <p:cNvSpPr txBox="1"/>
          <p:nvPr/>
        </p:nvSpPr>
        <p:spPr>
          <a:xfrm>
            <a:off x="26504" y="6494160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S2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22CE66BF-126C-0841-9F1E-65B22D30C8E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76603" y="3607451"/>
            <a:ext cx="3929976" cy="2886709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EEB31182-11D9-B540-9BFE-0F67230445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23234" y="3466402"/>
            <a:ext cx="4022356" cy="321242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F5E2F9E-1D13-B543-9CAE-A5A27838F040}"/>
              </a:ext>
            </a:extLst>
          </p:cNvPr>
          <p:cNvSpPr txBox="1"/>
          <p:nvPr/>
        </p:nvSpPr>
        <p:spPr>
          <a:xfrm>
            <a:off x="0" y="14292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82DE950-2F84-D947-9C53-5A01F35A7B9C}"/>
              </a:ext>
            </a:extLst>
          </p:cNvPr>
          <p:cNvSpPr txBox="1"/>
          <p:nvPr/>
        </p:nvSpPr>
        <p:spPr>
          <a:xfrm>
            <a:off x="1551203" y="343716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DA1A7FC-96F9-DA42-8AD6-88F942AAB79F}"/>
              </a:ext>
            </a:extLst>
          </p:cNvPr>
          <p:cNvSpPr txBox="1"/>
          <p:nvPr/>
        </p:nvSpPr>
        <p:spPr>
          <a:xfrm>
            <a:off x="6121802" y="343716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3C8C51B-C0A7-6C45-A997-CB953247879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13808" y="375501"/>
            <a:ext cx="6334592" cy="295351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B3EB696-8347-324C-9CF1-007537F61149}"/>
              </a:ext>
            </a:extLst>
          </p:cNvPr>
          <p:cNvSpPr txBox="1"/>
          <p:nvPr/>
        </p:nvSpPr>
        <p:spPr>
          <a:xfrm>
            <a:off x="6121802" y="14292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927183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E3E19CCC-9044-EF47-9BB0-459A11FBE6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248" t="1663" r="18978" b="7710"/>
          <a:stretch/>
        </p:blipFill>
        <p:spPr>
          <a:xfrm>
            <a:off x="4979924" y="416920"/>
            <a:ext cx="3034770" cy="313883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0080FFE-9C0A-9D41-AAE7-7F541F6502F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77" t="1652" r="1347" b="1209"/>
          <a:stretch/>
        </p:blipFill>
        <p:spPr>
          <a:xfrm>
            <a:off x="26504" y="3520029"/>
            <a:ext cx="4643365" cy="318131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03BCF27-9BA4-0949-A8BE-0D396C70F1E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08947" y="3984182"/>
            <a:ext cx="3621681" cy="2889463"/>
          </a:xfrm>
          <a:prstGeom prst="rect">
            <a:avLst/>
          </a:prstGeom>
        </p:spPr>
      </p:pic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2AE76156-F006-8943-8001-1083E214E409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11295" y="214489"/>
          <a:ext cx="2845708" cy="265661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22854">
                  <a:extLst>
                    <a:ext uri="{9D8B030D-6E8A-4147-A177-3AD203B41FA5}">
                      <a16:colId xmlns:a16="http://schemas.microsoft.com/office/drawing/2014/main" val="58107269"/>
                    </a:ext>
                  </a:extLst>
                </a:gridCol>
                <a:gridCol w="1422854">
                  <a:extLst>
                    <a:ext uri="{9D8B030D-6E8A-4147-A177-3AD203B41FA5}">
                      <a16:colId xmlns:a16="http://schemas.microsoft.com/office/drawing/2014/main" val="1697907124"/>
                    </a:ext>
                  </a:extLst>
                </a:gridCol>
              </a:tblGrid>
              <a:tr h="439094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Stag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No. of unique 300bp til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9663596"/>
                  </a:ext>
                </a:extLst>
              </a:tr>
              <a:tr h="274927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Sper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276,19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39035132"/>
                  </a:ext>
                </a:extLst>
              </a:tr>
              <a:tr h="274927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GV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1,08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07585703"/>
                  </a:ext>
                </a:extLst>
              </a:tr>
              <a:tr h="274927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In vivo MI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87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60048503"/>
                  </a:ext>
                </a:extLst>
              </a:tr>
              <a:tr h="274927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In vitro MII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2,43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9561001"/>
                  </a:ext>
                </a:extLst>
              </a:tr>
              <a:tr h="274927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2-Cel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6,09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065230"/>
                  </a:ext>
                </a:extLst>
              </a:tr>
              <a:tr h="274927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4-Cel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4,19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85371730"/>
                  </a:ext>
                </a:extLst>
              </a:tr>
              <a:tr h="274927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8-Cel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6,16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5247527"/>
                  </a:ext>
                </a:extLst>
              </a:tr>
              <a:tr h="274927"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16-Cel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/>
                        <a:t>31,62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4556267"/>
                  </a:ext>
                </a:extLst>
              </a:tr>
            </a:tbl>
          </a:graphicData>
        </a:graphic>
      </p:graphicFrame>
      <p:sp>
        <p:nvSpPr>
          <p:cNvPr id="27" name="TextBox 26">
            <a:extLst>
              <a:ext uri="{FF2B5EF4-FFF2-40B4-BE49-F238E27FC236}">
                <a16:creationId xmlns:a16="http://schemas.microsoft.com/office/drawing/2014/main" id="{45F09D6E-D92F-7C4E-9534-6F3EA77F3DEB}"/>
              </a:ext>
            </a:extLst>
          </p:cNvPr>
          <p:cNvSpPr txBox="1"/>
          <p:nvPr/>
        </p:nvSpPr>
        <p:spPr>
          <a:xfrm>
            <a:off x="5823812" y="27452"/>
            <a:ext cx="13837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perm unique tiles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C1DA812-4E07-5440-BCB7-78DE340F3053}"/>
              </a:ext>
            </a:extLst>
          </p:cNvPr>
          <p:cNvCxnSpPr>
            <a:cxnSpLocks/>
          </p:cNvCxnSpPr>
          <p:nvPr/>
        </p:nvCxnSpPr>
        <p:spPr>
          <a:xfrm flipV="1">
            <a:off x="6921884" y="665921"/>
            <a:ext cx="494410" cy="7358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24">
            <a:extLst>
              <a:ext uri="{FF2B5EF4-FFF2-40B4-BE49-F238E27FC236}">
                <a16:creationId xmlns:a16="http://schemas.microsoft.com/office/drawing/2014/main" id="{15154571-0471-5646-AC88-08F8F9936748}"/>
              </a:ext>
            </a:extLst>
          </p:cNvPr>
          <p:cNvSpPr/>
          <p:nvPr/>
        </p:nvSpPr>
        <p:spPr>
          <a:xfrm>
            <a:off x="7446733" y="215613"/>
            <a:ext cx="3666388" cy="83099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none">
            <a:spAutoFit/>
          </a:bodyPr>
          <a:lstStyle/>
          <a:p>
            <a:r>
              <a:rPr lang="en-US" sz="1200" dirty="0"/>
              <a:t>Immune response</a:t>
            </a:r>
          </a:p>
          <a:p>
            <a:r>
              <a:rPr lang="en-US" sz="1200" dirty="0"/>
              <a:t>Inflammatory response</a:t>
            </a:r>
          </a:p>
          <a:p>
            <a:r>
              <a:rPr lang="en-US" sz="1200" dirty="0"/>
              <a:t>Activate G-protein coupled receptor signaling pathway</a:t>
            </a:r>
          </a:p>
          <a:p>
            <a:r>
              <a:rPr lang="en-US" sz="1200" dirty="0"/>
              <a:t>Cell adhes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71882B5-F826-B04F-B8A1-E850B01BA3DA}"/>
              </a:ext>
            </a:extLst>
          </p:cNvPr>
          <p:cNvSpPr txBox="1"/>
          <p:nvPr/>
        </p:nvSpPr>
        <p:spPr>
          <a:xfrm>
            <a:off x="-31845" y="6466382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S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DF54FF7-CAC2-8C43-AD1C-8E2EA07773B0}"/>
              </a:ext>
            </a:extLst>
          </p:cNvPr>
          <p:cNvSpPr txBox="1"/>
          <p:nvPr/>
        </p:nvSpPr>
        <p:spPr>
          <a:xfrm>
            <a:off x="75234" y="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431501A-788B-CA44-890F-5BA80F7A1DDE}"/>
              </a:ext>
            </a:extLst>
          </p:cNvPr>
          <p:cNvSpPr txBox="1"/>
          <p:nvPr/>
        </p:nvSpPr>
        <p:spPr>
          <a:xfrm>
            <a:off x="4758851" y="4758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3B3E5B2-CB2E-724E-B08B-197C40CBE273}"/>
              </a:ext>
            </a:extLst>
          </p:cNvPr>
          <p:cNvSpPr txBox="1"/>
          <p:nvPr/>
        </p:nvSpPr>
        <p:spPr>
          <a:xfrm>
            <a:off x="4762066" y="3112912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6DA3317-7D93-3049-96CD-624DB1684770}"/>
              </a:ext>
            </a:extLst>
          </p:cNvPr>
          <p:cNvSpPr txBox="1"/>
          <p:nvPr/>
        </p:nvSpPr>
        <p:spPr>
          <a:xfrm>
            <a:off x="26504" y="301632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0FD6A19-C47D-5642-9590-D0892A3DB74E}"/>
              </a:ext>
            </a:extLst>
          </p:cNvPr>
          <p:cNvSpPr txBox="1"/>
          <p:nvPr/>
        </p:nvSpPr>
        <p:spPr>
          <a:xfrm>
            <a:off x="8459874" y="2831659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B2041EC-CA4E-B34A-9DFF-41BC8B02D2E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080917" y="3281885"/>
            <a:ext cx="4111083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88040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D93CD85-CD87-BA43-88ED-3D4DD2767047}"/>
              </a:ext>
            </a:extLst>
          </p:cNvPr>
          <p:cNvSpPr txBox="1"/>
          <p:nvPr/>
        </p:nvSpPr>
        <p:spPr>
          <a:xfrm>
            <a:off x="-11596" y="6494160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S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DD4CE89-CA01-744E-A05A-F088A71B90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13313" y="3535148"/>
            <a:ext cx="3222519" cy="338328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4FEA626-8A0F-9D4D-9020-028AB1EFF6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01198" y="3535148"/>
            <a:ext cx="3218067" cy="338328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FE1A1E9-E9E2-0B48-9FB9-D2F4A56A23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29736" y="3535148"/>
            <a:ext cx="3252595" cy="338328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38E7541-FFF4-6944-9DDD-89C8C283E8E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05474" y="175161"/>
            <a:ext cx="3197700" cy="338328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4872F41-199B-7E4C-81F2-878B54BAB3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68540" y="175161"/>
            <a:ext cx="3218067" cy="338328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C0C092E-F421-1145-BD53-E649254B3E9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4999" y="10883"/>
            <a:ext cx="3935639" cy="355844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5BACE27F-EA6B-C542-A7DE-3A6E4EF9461E}"/>
              </a:ext>
            </a:extLst>
          </p:cNvPr>
          <p:cNvSpPr txBox="1"/>
          <p:nvPr/>
        </p:nvSpPr>
        <p:spPr>
          <a:xfrm>
            <a:off x="879362" y="55628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F1FE2B9-0B96-6548-9156-58617F39C853}"/>
              </a:ext>
            </a:extLst>
          </p:cNvPr>
          <p:cNvSpPr txBox="1"/>
          <p:nvPr/>
        </p:nvSpPr>
        <p:spPr>
          <a:xfrm>
            <a:off x="4709682" y="55628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B9E5A41-A8E4-DC4C-9458-6AF41C147CBF}"/>
              </a:ext>
            </a:extLst>
          </p:cNvPr>
          <p:cNvSpPr txBox="1"/>
          <p:nvPr/>
        </p:nvSpPr>
        <p:spPr>
          <a:xfrm>
            <a:off x="8369393" y="55628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CF6A62C-A369-8B4F-AC6D-88412DFF1BF2}"/>
              </a:ext>
            </a:extLst>
          </p:cNvPr>
          <p:cNvSpPr txBox="1"/>
          <p:nvPr/>
        </p:nvSpPr>
        <p:spPr>
          <a:xfrm>
            <a:off x="8364769" y="3636262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EF10549-AE30-114B-9F04-4FFF98E1D471}"/>
              </a:ext>
            </a:extLst>
          </p:cNvPr>
          <p:cNvSpPr txBox="1"/>
          <p:nvPr/>
        </p:nvSpPr>
        <p:spPr>
          <a:xfrm>
            <a:off x="4709682" y="363626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E35E5EF-2B7E-B541-8006-788A9BE02526}"/>
              </a:ext>
            </a:extLst>
          </p:cNvPr>
          <p:cNvSpPr txBox="1"/>
          <p:nvPr/>
        </p:nvSpPr>
        <p:spPr>
          <a:xfrm>
            <a:off x="842259" y="363316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697145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103</Words>
  <Application>Microsoft Macintosh PowerPoint</Application>
  <PresentationFormat>Widescreen</PresentationFormat>
  <Paragraphs>67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lie duan</dc:creator>
  <cp:lastModifiedBy>ellie duan</cp:lastModifiedBy>
  <cp:revision>6</cp:revision>
  <dcterms:created xsi:type="dcterms:W3CDTF">2019-03-08T15:51:41Z</dcterms:created>
  <dcterms:modified xsi:type="dcterms:W3CDTF">2019-04-30T20:05:10Z</dcterms:modified>
</cp:coreProperties>
</file>